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61" autoAdjust="0"/>
    <p:restoredTop sz="89881" autoAdjust="0"/>
  </p:normalViewPr>
  <p:slideViewPr>
    <p:cSldViewPr snapToGrid="0">
      <p:cViewPr>
        <p:scale>
          <a:sx n="100" d="100"/>
          <a:sy n="100" d="100"/>
        </p:scale>
        <p:origin x="-840" y="-12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69563A-507D-45BC-A743-B18B7B8E5631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6CE24B-48E8-4D7C-AAA7-62774771E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17423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S2</a:t>
            </a:r>
            <a:endParaRPr kumimoji="1" lang="en-US" altLang="ja-JP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Representative flow cytometry figures for increase and decrease in CD8+ EMT and </a:t>
            </a:r>
            <a:r>
              <a:rPr kumimoji="1" lang="en-US" altLang="ja-JP" dirty="0" err="1"/>
              <a:t>Teff</a:t>
            </a:r>
            <a:r>
              <a:rPr kumimoji="1" lang="en-US" altLang="ja-JP"/>
              <a:t> proportion groups </a:t>
            </a:r>
            <a:r>
              <a:rPr kumimoji="1" lang="en-US" altLang="ja-JP" dirty="0"/>
              <a:t>before and after treatment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4F965F0-5D48-4CB1-97B8-DB3F7F50CF6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8469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8836C42-EE38-CB83-5DD0-1CC366B716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6DBA412A-9502-D1D4-333F-6ADE2FCF08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1F923B3-A3B6-6C08-E0A9-AB3D5872F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02B36A4-90FC-5261-8F0A-00E579AAF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443BD69-BE37-756D-66C5-AC60490EC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63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143B6D4-A0E0-89AC-F903-B1FBA5BD6F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95DE98B3-5BD6-AF8A-D02B-8E0DA4C5D0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59AD789-D41A-19AC-4A94-B26A38811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F61988F-F2D3-264A-A907-ADAC15CD5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AC8E95A-626C-3C11-723A-A1292D2E5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179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59E67515-7CFC-1A66-E19A-823D3B6A6B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23D249F6-4DA6-2F0A-7918-99BB7B8EE2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0287E90-F352-039B-4F99-BE1B3B1E3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873E3AA-C0AE-CF1B-4054-72BB79584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DAFFC97-E63F-15DC-B421-EAF44D5A0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745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56BC837-BC04-57C2-938B-1F3B1A4AB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1885A710-24F6-E350-7518-94949610B6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581CFA3-DA57-C057-6B70-5A6270333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4F0E098-2F6C-2394-9E68-73006DBCE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B7AEA29-8E6B-C175-A11D-F09424C48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900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DD4CB4E-EF22-5BB7-4092-0A17F88F46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25CB4E17-7370-F532-C49F-F225E313B4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34C718B-A89D-3E1E-7536-37C5D3ED2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B9C0467-C02A-FC02-A353-34D5B19CE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CB01FC1-8590-B9C8-A3B9-35D7E8F0B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597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4168C08-B84D-A821-AF63-393C5B443B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F45539D5-193D-4B6B-6A73-C56904FB32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381CBFBD-A24C-FEBF-A273-3CAC0E2B5E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07C23991-92AF-76AD-74B5-6E7293707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422C9126-3DF6-FF71-9612-046EE30D3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B68BE47F-6EAE-65D9-1B49-20CD23053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3352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E05525C-7954-9ABD-8069-19A43AADD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63A344AF-0BDC-70C2-B7A8-A1E580DBB5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9B2D4F97-76BF-9949-B836-88CEAE71B7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11118A5B-525C-2834-8982-78E84518FD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6E71F3C2-29B2-207C-13E1-E17071F532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1143D439-E5D4-486E-64FC-B6F87A02C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B9DE5745-EF08-B219-6CF2-003A3E839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DBFCBF8A-651A-91E3-960B-D281FC2C7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3307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5300644-BD90-A462-714E-3EA7CA14E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3D1B0B5C-7380-5B03-C263-4212EA363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F42DA26C-E757-E946-A75D-EDD7A10C6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8CAB22EF-384F-4ACC-9721-3291FE254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8398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69D1F5E7-A0A4-DF81-921F-1E04D6263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B3A7EFAE-A3DA-B22F-722E-D044ACB85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9C55F6EA-E87A-EAC8-C36F-EBEE0C6E2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2917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0600A61-9AF4-E4A0-215A-5F34697F3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F9DE36E7-04A5-A75F-04BD-C4C35D02E1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5BC6EA5C-4E58-83E2-C490-53E6A6EA74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D3E9D229-3100-CF65-B83A-F0BDBD251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36936F75-9135-68EC-B07C-9B8A2BE4E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320A63C-4F54-E23D-ADD9-49880B8FE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320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13FFCBE-AEDB-8D95-C1BD-DB79F259DB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57E0E010-A014-8423-9DFD-D01D10431F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A65F16FB-2FC2-F44A-F22A-D002104A49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1EAF2E04-7628-E8BC-6DCE-7D44D43DB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CA67814C-15E7-2DE5-4ED9-F1E8F14E9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386136F-531C-FA1E-FF73-34383F0AC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843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F24C1F9C-8854-ED6B-C46F-1812D78FA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E52DF3C1-F18E-57B9-6EB6-76E06389B8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33F43B1-AA61-DCD4-493C-62E8C7BE77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44290-437D-46B5-8083-07702E8DCA00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5EF6102-A649-96DC-511F-F066CA02BA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F95AD6E-BEC6-8018-5338-CB980A76CB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27067F-EE92-497C-849D-828E97C0D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652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B67DB264-509F-2DF9-2749-CE1404C3BB3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F738AF36-F90D-DB34-AAC2-066D9164A4DC}"/>
              </a:ext>
            </a:extLst>
          </p:cNvPr>
          <p:cNvSpPr txBox="1"/>
          <p:nvPr/>
        </p:nvSpPr>
        <p:spPr>
          <a:xfrm>
            <a:off x="256748" y="2264960"/>
            <a:ext cx="1231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Before </a:t>
            </a:r>
          </a:p>
          <a:p>
            <a:pPr algn="ctr"/>
            <a:r>
              <a:rPr kumimoji="1" lang="en-US" altLang="ja-JP" dirty="0"/>
              <a:t>treatment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61FE31D1-7512-B412-92FB-C4BEB1279AE0}"/>
              </a:ext>
            </a:extLst>
          </p:cNvPr>
          <p:cNvSpPr txBox="1"/>
          <p:nvPr/>
        </p:nvSpPr>
        <p:spPr>
          <a:xfrm>
            <a:off x="252719" y="5057754"/>
            <a:ext cx="1231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After</a:t>
            </a:r>
            <a:r>
              <a:rPr kumimoji="1" lang="en-US" altLang="ja-JP" dirty="0"/>
              <a:t> </a:t>
            </a:r>
          </a:p>
          <a:p>
            <a:pPr algn="ctr"/>
            <a:r>
              <a:rPr kumimoji="1" lang="en-US" altLang="ja-JP" dirty="0"/>
              <a:t>treatment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710A8120-ED37-5F7C-BC87-B2E3E789441D}"/>
              </a:ext>
            </a:extLst>
          </p:cNvPr>
          <p:cNvSpPr txBox="1"/>
          <p:nvPr/>
        </p:nvSpPr>
        <p:spPr>
          <a:xfrm>
            <a:off x="3411682" y="454504"/>
            <a:ext cx="1439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CD8+ TEM</a:t>
            </a:r>
          </a:p>
          <a:p>
            <a:pPr algn="ctr"/>
            <a:r>
              <a:rPr lang="en-US" altLang="ja-JP" dirty="0"/>
              <a:t>(Lower left)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DD0E4FC1-78EC-5B21-465C-B11668736BA8}"/>
              </a:ext>
            </a:extLst>
          </p:cNvPr>
          <p:cNvSpPr txBox="1"/>
          <p:nvPr/>
        </p:nvSpPr>
        <p:spPr>
          <a:xfrm>
            <a:off x="4063133" y="1088735"/>
            <a:ext cx="2641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I</a:t>
            </a:r>
            <a:r>
              <a:rPr kumimoji="1" lang="en-US" altLang="ja-JP" dirty="0"/>
              <a:t>ncreased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24BC69DC-BD77-FF85-8D6A-B291B64C5EC7}"/>
              </a:ext>
            </a:extLst>
          </p:cNvPr>
          <p:cNvSpPr txBox="1"/>
          <p:nvPr/>
        </p:nvSpPr>
        <p:spPr>
          <a:xfrm>
            <a:off x="1484146" y="1088735"/>
            <a:ext cx="2578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De</a:t>
            </a:r>
            <a:r>
              <a:rPr kumimoji="1" lang="en-US" altLang="ja-JP" dirty="0"/>
              <a:t>creased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A0FB8D40-A2E0-2519-D459-CCAA2E03CF39}"/>
              </a:ext>
            </a:extLst>
          </p:cNvPr>
          <p:cNvSpPr txBox="1"/>
          <p:nvPr/>
        </p:nvSpPr>
        <p:spPr>
          <a:xfrm>
            <a:off x="8667474" y="454504"/>
            <a:ext cx="1576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CD8+ Teff</a:t>
            </a:r>
          </a:p>
          <a:p>
            <a:pPr algn="ctr"/>
            <a:r>
              <a:rPr lang="en-US" altLang="ja-JP" dirty="0"/>
              <a:t>(Lower right)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D325ADC6-A529-C05B-1DC4-E19420518631}"/>
              </a:ext>
            </a:extLst>
          </p:cNvPr>
          <p:cNvSpPr txBox="1"/>
          <p:nvPr/>
        </p:nvSpPr>
        <p:spPr>
          <a:xfrm>
            <a:off x="9466254" y="1099691"/>
            <a:ext cx="2558880" cy="381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I</a:t>
            </a:r>
            <a:r>
              <a:rPr kumimoji="1" lang="en-US" altLang="ja-JP" dirty="0"/>
              <a:t>ncreased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71372D75-1204-8E95-88D4-6E99077B8F13}"/>
              </a:ext>
            </a:extLst>
          </p:cNvPr>
          <p:cNvSpPr txBox="1"/>
          <p:nvPr/>
        </p:nvSpPr>
        <p:spPr>
          <a:xfrm>
            <a:off x="6704206" y="1088735"/>
            <a:ext cx="276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De</a:t>
            </a:r>
            <a:r>
              <a:rPr kumimoji="1" lang="en-US" altLang="ja-JP" dirty="0"/>
              <a:t>creased</a:t>
            </a:r>
            <a:endParaRPr kumimoji="1" lang="ja-JP" altLang="en-US" dirty="0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54F92B52-B1A0-F253-4D24-58969BDFC7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4433" y="4311108"/>
            <a:ext cx="2366690" cy="2313761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xmlns="" id="{6169B018-0FCF-B1EC-020F-B9D19CD8B3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05049" y="1583668"/>
            <a:ext cx="2366690" cy="2313761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xmlns="" id="{14C1DD8F-540C-A89E-8A16-C97F7300AFF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58448" y="1593095"/>
            <a:ext cx="2366690" cy="231376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xmlns="" id="{E717CDF7-D363-26EA-109E-2EEEE82FEC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63833" y="4311108"/>
            <a:ext cx="2366690" cy="2313761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D7121AC1-6B8E-8BB6-5F6B-568F033BAAF0}"/>
              </a:ext>
            </a:extLst>
          </p:cNvPr>
          <p:cNvSpPr txBox="1"/>
          <p:nvPr/>
        </p:nvSpPr>
        <p:spPr>
          <a:xfrm>
            <a:off x="0" y="45977"/>
            <a:ext cx="3200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8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</a:t>
            </a: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2</a:t>
            </a:r>
            <a:endParaRPr lang="en-US" altLang="ja-JP" sz="1800" b="1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xmlns="" id="{68BE12DC-4010-7368-F888-6102D6E2DF11}"/>
              </a:ext>
            </a:extLst>
          </p:cNvPr>
          <p:cNvCxnSpPr>
            <a:cxnSpLocks/>
          </p:cNvCxnSpPr>
          <p:nvPr/>
        </p:nvCxnSpPr>
        <p:spPr>
          <a:xfrm>
            <a:off x="353694" y="1074655"/>
            <a:ext cx="11742519" cy="9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6" name="図 15">
            <a:extLst>
              <a:ext uri="{FF2B5EF4-FFF2-40B4-BE49-F238E27FC236}">
                <a16:creationId xmlns:a16="http://schemas.microsoft.com/office/drawing/2014/main" xmlns="" id="{663B1FF7-F02E-C4DF-0B22-6F01C445E46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08759" y="1593095"/>
            <a:ext cx="2366690" cy="2313761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xmlns="" id="{09BC9906-7C68-34C3-1108-0C8ACAE6F9F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14144" y="4311108"/>
            <a:ext cx="2366690" cy="2313761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CB651E1F-A0FD-ACD8-CD43-F3A0333D4D6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16709" y="1583668"/>
            <a:ext cx="2366690" cy="2313761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435DC36D-8571-80DB-77C0-EB23FF3307D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16709" y="4311108"/>
            <a:ext cx="2366690" cy="2313761"/>
          </a:xfrm>
          <a:prstGeom prst="rect">
            <a:avLst/>
          </a:prstGeom>
        </p:spPr>
      </p:pic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xmlns="" id="{D97D7EE2-466F-80D9-DD08-70700A20EDE4}"/>
              </a:ext>
            </a:extLst>
          </p:cNvPr>
          <p:cNvCxnSpPr>
            <a:cxnSpLocks/>
          </p:cNvCxnSpPr>
          <p:nvPr/>
        </p:nvCxnSpPr>
        <p:spPr>
          <a:xfrm>
            <a:off x="345839" y="4139940"/>
            <a:ext cx="11742519" cy="9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xmlns="" id="{085314ED-B167-EBDD-D60A-07C0A45BD7AF}"/>
              </a:ext>
            </a:extLst>
          </p:cNvPr>
          <p:cNvCxnSpPr>
            <a:cxnSpLocks/>
          </p:cNvCxnSpPr>
          <p:nvPr/>
        </p:nvCxnSpPr>
        <p:spPr>
          <a:xfrm>
            <a:off x="355262" y="1472154"/>
            <a:ext cx="11742519" cy="9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AABC813E-A99E-4105-E742-7F9A14BB652F}"/>
              </a:ext>
            </a:extLst>
          </p:cNvPr>
          <p:cNvCxnSpPr>
            <a:cxnSpLocks/>
          </p:cNvCxnSpPr>
          <p:nvPr/>
        </p:nvCxnSpPr>
        <p:spPr>
          <a:xfrm>
            <a:off x="1497474" y="454504"/>
            <a:ext cx="0" cy="62008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xmlns="" id="{C24A3381-E330-F0B2-6999-925C0F74BD2E}"/>
              </a:ext>
            </a:extLst>
          </p:cNvPr>
          <p:cNvCxnSpPr>
            <a:cxnSpLocks/>
          </p:cNvCxnSpPr>
          <p:nvPr/>
        </p:nvCxnSpPr>
        <p:spPr>
          <a:xfrm>
            <a:off x="4063135" y="1069939"/>
            <a:ext cx="0" cy="55775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xmlns="" id="{BAE6F5DC-26CF-01CA-6D34-31C52A9CF871}"/>
              </a:ext>
            </a:extLst>
          </p:cNvPr>
          <p:cNvCxnSpPr>
            <a:cxnSpLocks/>
          </p:cNvCxnSpPr>
          <p:nvPr/>
        </p:nvCxnSpPr>
        <p:spPr>
          <a:xfrm>
            <a:off x="9466260" y="1071508"/>
            <a:ext cx="0" cy="55775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xmlns="" id="{DCBC8DBB-AB18-0078-1A71-8D1B28EDFC6B}"/>
              </a:ext>
            </a:extLst>
          </p:cNvPr>
          <p:cNvCxnSpPr>
            <a:cxnSpLocks/>
          </p:cNvCxnSpPr>
          <p:nvPr/>
        </p:nvCxnSpPr>
        <p:spPr>
          <a:xfrm>
            <a:off x="6704210" y="415309"/>
            <a:ext cx="0" cy="62321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BAD095F0-6A1F-3667-420C-312E56058EC8}"/>
              </a:ext>
            </a:extLst>
          </p:cNvPr>
          <p:cNvSpPr txBox="1"/>
          <p:nvPr/>
        </p:nvSpPr>
        <p:spPr>
          <a:xfrm rot="16200000">
            <a:off x="693497" y="2430073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22F5B198-366F-AF46-2F53-A1D71EA2B25F}"/>
              </a:ext>
            </a:extLst>
          </p:cNvPr>
          <p:cNvSpPr txBox="1"/>
          <p:nvPr/>
        </p:nvSpPr>
        <p:spPr>
          <a:xfrm>
            <a:off x="1944604" y="3719967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CAFF39E0-E47F-0DC1-7348-5765D318C41F}"/>
              </a:ext>
            </a:extLst>
          </p:cNvPr>
          <p:cNvSpPr txBox="1"/>
          <p:nvPr/>
        </p:nvSpPr>
        <p:spPr>
          <a:xfrm rot="16200000">
            <a:off x="3268585" y="2431644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B743B1E5-836A-25ED-CF89-C8D5D8F7B290}"/>
              </a:ext>
            </a:extLst>
          </p:cNvPr>
          <p:cNvSpPr txBox="1"/>
          <p:nvPr/>
        </p:nvSpPr>
        <p:spPr>
          <a:xfrm>
            <a:off x="4519692" y="3721538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1A7836E3-CB26-8FEF-A8E7-8870E7644BDD}"/>
              </a:ext>
            </a:extLst>
          </p:cNvPr>
          <p:cNvSpPr txBox="1"/>
          <p:nvPr/>
        </p:nvSpPr>
        <p:spPr>
          <a:xfrm rot="16200000">
            <a:off x="6058922" y="2431641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2418CF30-6146-8D8B-1998-AAF9BC9F5956}"/>
              </a:ext>
            </a:extLst>
          </p:cNvPr>
          <p:cNvSpPr txBox="1"/>
          <p:nvPr/>
        </p:nvSpPr>
        <p:spPr>
          <a:xfrm>
            <a:off x="7310029" y="3721535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EBE29EF7-31FA-8F60-5060-D80B50538475}"/>
              </a:ext>
            </a:extLst>
          </p:cNvPr>
          <p:cNvSpPr txBox="1"/>
          <p:nvPr/>
        </p:nvSpPr>
        <p:spPr>
          <a:xfrm rot="16200000">
            <a:off x="8726701" y="2450495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5F6B8523-2861-3EAA-E4D4-DE7515FAA991}"/>
              </a:ext>
            </a:extLst>
          </p:cNvPr>
          <p:cNvSpPr txBox="1"/>
          <p:nvPr/>
        </p:nvSpPr>
        <p:spPr>
          <a:xfrm>
            <a:off x="9977808" y="3740389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A6441428-D66B-886D-D10A-851957D1E8A7}"/>
              </a:ext>
            </a:extLst>
          </p:cNvPr>
          <p:cNvSpPr txBox="1"/>
          <p:nvPr/>
        </p:nvSpPr>
        <p:spPr>
          <a:xfrm rot="16200000">
            <a:off x="704493" y="5165418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6AA11521-DC50-5B9D-32D5-C1CFAD118074}"/>
              </a:ext>
            </a:extLst>
          </p:cNvPr>
          <p:cNvSpPr txBox="1"/>
          <p:nvPr/>
        </p:nvSpPr>
        <p:spPr>
          <a:xfrm>
            <a:off x="1955600" y="6455312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5F8C8D80-E178-4E7C-40B2-82E194B9D799}"/>
              </a:ext>
            </a:extLst>
          </p:cNvPr>
          <p:cNvSpPr txBox="1"/>
          <p:nvPr/>
        </p:nvSpPr>
        <p:spPr>
          <a:xfrm rot="16200000">
            <a:off x="3306295" y="5184270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4132C977-EE01-7509-2955-60BE97264E27}"/>
              </a:ext>
            </a:extLst>
          </p:cNvPr>
          <p:cNvSpPr txBox="1"/>
          <p:nvPr/>
        </p:nvSpPr>
        <p:spPr>
          <a:xfrm>
            <a:off x="4557402" y="6474164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825B0B66-C13F-D52E-C86A-4A7DCF9CA5FB}"/>
              </a:ext>
            </a:extLst>
          </p:cNvPr>
          <p:cNvSpPr txBox="1"/>
          <p:nvPr/>
        </p:nvSpPr>
        <p:spPr>
          <a:xfrm rot="16200000">
            <a:off x="6058919" y="5184269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1D368CA1-CF52-1F63-C83C-47349A40244F}"/>
              </a:ext>
            </a:extLst>
          </p:cNvPr>
          <p:cNvSpPr txBox="1"/>
          <p:nvPr/>
        </p:nvSpPr>
        <p:spPr>
          <a:xfrm>
            <a:off x="7310026" y="6474163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CD05ACC1-70C1-0DE6-CD09-60534069566B}"/>
              </a:ext>
            </a:extLst>
          </p:cNvPr>
          <p:cNvSpPr txBox="1"/>
          <p:nvPr/>
        </p:nvSpPr>
        <p:spPr>
          <a:xfrm rot="16200000">
            <a:off x="8707849" y="5174843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CR7</a:t>
            </a:r>
            <a:endParaRPr kumimoji="1" lang="ja-JP" altLang="en-US" sz="100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CB1DE61C-1DCD-A8A9-A0A4-A56205A81938}"/>
              </a:ext>
            </a:extLst>
          </p:cNvPr>
          <p:cNvSpPr txBox="1"/>
          <p:nvPr/>
        </p:nvSpPr>
        <p:spPr>
          <a:xfrm>
            <a:off x="9958956" y="6464737"/>
            <a:ext cx="198606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D45RA</a:t>
            </a:r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875493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7</TotalTime>
  <Words>65</Words>
  <Application>Microsoft Office PowerPoint</Application>
  <PresentationFormat>Custom</PresentationFormat>
  <Paragraphs>3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FORTE   M.Tsunoda</cp:lastModifiedBy>
  <cp:revision>5</cp:revision>
  <dcterms:created xsi:type="dcterms:W3CDTF">2024-03-06T12:44:52Z</dcterms:created>
  <dcterms:modified xsi:type="dcterms:W3CDTF">2024-03-13T01:05:53Z</dcterms:modified>
</cp:coreProperties>
</file>